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2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MYC</a:t>
            </a:r>
            <a:r>
              <a:rPr lang="en-GB" sz="1600" dirty="0" smtClean="0"/>
              <a:t> gene. A) Wild (Template </a:t>
            </a:r>
            <a:r>
              <a:rPr lang="en-US" sz="1600" dirty="0" smtClean="0"/>
              <a:t>1nkp_A</a:t>
            </a:r>
            <a:endParaRPr lang="en-GB" sz="1600" dirty="0"/>
          </a:p>
          <a:p>
            <a:pPr algn="ctr"/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nkp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285728"/>
            <a:ext cx="3143272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29759" y="142852"/>
            <a:ext cx="3557083" cy="306387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42910" y="3286124"/>
            <a:ext cx="3143272" cy="26955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86124"/>
            <a:ext cx="3571900" cy="2703513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6</cp:revision>
  <dcterms:created xsi:type="dcterms:W3CDTF">2018-05-10T07:33:24Z</dcterms:created>
  <dcterms:modified xsi:type="dcterms:W3CDTF">2018-05-29T07:34:37Z</dcterms:modified>
</cp:coreProperties>
</file>